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05B144D-A814-F92E-2FCE-6C74B55708D4}" name="Roberto Foa" initials="RF" userId="S::roberto.foa@uniroma1.it::0be24bac-262e-442f-92c2-178946b7c2c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82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2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2399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4509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8776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267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6244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6664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3743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0293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4942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7038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3011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A915E-A723-44EC-8B02-B8ED3B8C02AD}" type="datetimeFigureOut">
              <a:rPr lang="it-IT" smtClean="0"/>
              <a:t>04/06/20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2333A-326C-4C36-BD98-19D2E69F8D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1924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538014"/>
              </p:ext>
            </p:extLst>
          </p:nvPr>
        </p:nvGraphicFramePr>
        <p:xfrm>
          <a:off x="934155" y="253067"/>
          <a:ext cx="9898601" cy="6722827"/>
        </p:xfrm>
        <a:graphic>
          <a:graphicData uri="http://schemas.openxmlformats.org/drawingml/2006/table">
            <a:tbl>
              <a:tblPr firstRow="1" bandRow="1">
                <a:tableStyleId>{8799B23B-EC83-4686-B30A-512413B5E67A}</a:tableStyleId>
              </a:tblPr>
              <a:tblGrid>
                <a:gridCol w="75381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8571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41846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49514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7597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316897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34392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40867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321275">
                <a:tc gridSpan="4">
                  <a:txBody>
                    <a:bodyPr/>
                    <a:lstStyle/>
                    <a:p>
                      <a:pPr algn="ctr"/>
                      <a:r>
                        <a:rPr lang="it-IT" sz="1100" b="1" dirty="0" err="1" smtClean="0"/>
                        <a:t>EuroClonality</a:t>
                      </a:r>
                      <a:r>
                        <a:rPr lang="it-IT" sz="1100" b="1" dirty="0" smtClean="0"/>
                        <a:t>-NGS </a:t>
                      </a:r>
                      <a:r>
                        <a:rPr lang="it-IT" sz="1100" b="1" dirty="0"/>
                        <a:t>Work flow 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it-IT" sz="1100" dirty="0"/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1" dirty="0" err="1" smtClean="0"/>
                        <a:t>LymphoTrack</a:t>
                      </a:r>
                      <a:r>
                        <a:rPr lang="en-US" sz="1100" dirty="0" smtClean="0"/>
                        <a:t>®</a:t>
                      </a:r>
                      <a:r>
                        <a:rPr lang="it-IT" sz="1100" b="1" dirty="0" smtClean="0"/>
                        <a:t> Work flow </a:t>
                      </a:r>
                      <a:endParaRPr lang="it-IT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it-IT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06840"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ample </a:t>
                      </a:r>
                      <a:r>
                        <a:rPr lang="it-IT" sz="800" b="1" dirty="0" err="1"/>
                        <a:t>collection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700" dirty="0"/>
                        <a:t>• FFPE</a:t>
                      </a:r>
                    </a:p>
                    <a:p>
                      <a:pPr algn="l"/>
                      <a:r>
                        <a:rPr lang="en-US" sz="700" dirty="0"/>
                        <a:t>• peripheral blood</a:t>
                      </a:r>
                    </a:p>
                    <a:p>
                      <a:pPr algn="l"/>
                      <a:r>
                        <a:rPr lang="en-US" sz="700" dirty="0"/>
                        <a:t>• bone marrow</a:t>
                      </a:r>
                    </a:p>
                    <a:p>
                      <a:pPr algn="l"/>
                      <a:r>
                        <a:rPr lang="en-US" sz="700" dirty="0"/>
                        <a:t>• fresh tissue</a:t>
                      </a:r>
                      <a:endParaRPr lang="it-IT" sz="7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7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ample </a:t>
                      </a:r>
                      <a:r>
                        <a:rPr lang="it-IT" sz="800" b="1" dirty="0" err="1"/>
                        <a:t>collection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700" dirty="0"/>
                        <a:t>• FFPE</a:t>
                      </a:r>
                    </a:p>
                    <a:p>
                      <a:pPr algn="l"/>
                      <a:r>
                        <a:rPr lang="en-US" sz="700" dirty="0"/>
                        <a:t>• peripheral blood</a:t>
                      </a:r>
                    </a:p>
                    <a:p>
                      <a:pPr algn="l"/>
                      <a:r>
                        <a:rPr lang="en-US" sz="700" dirty="0"/>
                        <a:t>• bone marrow</a:t>
                      </a:r>
                    </a:p>
                    <a:p>
                      <a:pPr algn="l"/>
                      <a:r>
                        <a:rPr lang="en-US" sz="700" dirty="0"/>
                        <a:t>• fresh tissue</a:t>
                      </a:r>
                      <a:endParaRPr lang="it-IT" sz="7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7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0249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1" dirty="0"/>
                        <a:t>STEP 2</a:t>
                      </a:r>
                    </a:p>
                    <a:p>
                      <a:pPr algn="ctr"/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DNA </a:t>
                      </a:r>
                      <a:r>
                        <a:rPr lang="it-IT" sz="800" b="1" dirty="0" err="1"/>
                        <a:t>extraction</a:t>
                      </a:r>
                      <a:endParaRPr lang="it-IT" sz="800" b="1" dirty="0"/>
                    </a:p>
                    <a:p>
                      <a:pPr algn="ctr"/>
                      <a:r>
                        <a:rPr lang="it-IT" sz="800" b="1" dirty="0"/>
                        <a:t>and </a:t>
                      </a:r>
                      <a:r>
                        <a:rPr lang="it-IT" sz="800" b="1" dirty="0" err="1"/>
                        <a:t>quantification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it-IT" sz="700" dirty="0"/>
                        <a:t>•</a:t>
                      </a:r>
                      <a:r>
                        <a:rPr lang="it-IT" sz="7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Qubit</a:t>
                      </a:r>
                      <a:endParaRPr lang="it-IT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l" defTabSz="914400" rtl="0" eaLnBrk="1" latinLnBrk="0" hangingPunct="1"/>
                      <a:r>
                        <a:rPr lang="it-IT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•</a:t>
                      </a:r>
                      <a:r>
                        <a:rPr lang="it-IT" sz="7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anoDrop</a:t>
                      </a:r>
                      <a:endParaRPr lang="it-IT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l" defTabSz="914400" rtl="0" eaLnBrk="1" latinLnBrk="0" hangingPunct="1"/>
                      <a:r>
                        <a:rPr lang="it-IT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•</a:t>
                      </a:r>
                      <a:r>
                        <a:rPr lang="it-IT" sz="7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apeStation</a:t>
                      </a:r>
                      <a:r>
                        <a:rPr lang="it-IT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/</a:t>
                      </a:r>
                      <a:r>
                        <a:rPr lang="it-IT" sz="7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Bioanalyzer</a:t>
                      </a:r>
                      <a:endParaRPr lang="it-IT" sz="7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7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1" dirty="0"/>
                        <a:t>STEP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DNA </a:t>
                      </a:r>
                      <a:r>
                        <a:rPr lang="it-IT" sz="800" b="1" dirty="0" err="1"/>
                        <a:t>extraction</a:t>
                      </a:r>
                      <a:endParaRPr lang="it-IT" sz="800" b="1" dirty="0"/>
                    </a:p>
                    <a:p>
                      <a:pPr algn="ctr"/>
                      <a:r>
                        <a:rPr lang="it-IT" sz="800" b="1" dirty="0"/>
                        <a:t>and </a:t>
                      </a:r>
                      <a:r>
                        <a:rPr lang="it-IT" sz="800" b="1" dirty="0" err="1"/>
                        <a:t>quantification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700" dirty="0"/>
                        <a:t>•</a:t>
                      </a:r>
                      <a:r>
                        <a:rPr lang="it-IT" sz="700" dirty="0" err="1"/>
                        <a:t>Qubit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</a:t>
                      </a:r>
                      <a:r>
                        <a:rPr lang="it-IT" sz="700" dirty="0" err="1"/>
                        <a:t>NanoDrop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</a:t>
                      </a:r>
                      <a:r>
                        <a:rPr lang="it-IT" sz="700" dirty="0" err="1"/>
                        <a:t>TapeStation</a:t>
                      </a:r>
                      <a:r>
                        <a:rPr lang="it-IT" sz="700" dirty="0"/>
                        <a:t>/</a:t>
                      </a:r>
                      <a:r>
                        <a:rPr lang="it-IT" sz="700" dirty="0" err="1"/>
                        <a:t>Bioanalyzer</a:t>
                      </a:r>
                      <a:endParaRPr lang="it-IT" sz="7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7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550333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1" dirty="0"/>
                        <a:t>STEP 3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1" dirty="0"/>
                        <a:t>(First PCR)</a:t>
                      </a:r>
                    </a:p>
                    <a:p>
                      <a:pPr algn="ctr"/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Hi</a:t>
                      </a:r>
                      <a:r>
                        <a:rPr lang="it-IT" sz="800" dirty="0"/>
                        <a:t>g</a:t>
                      </a:r>
                      <a:r>
                        <a:rPr lang="it-IT" sz="800" b="1" dirty="0"/>
                        <a:t>hly </a:t>
                      </a:r>
                      <a:r>
                        <a:rPr lang="it-IT" sz="800" b="1" dirty="0" err="1"/>
                        <a:t>extended</a:t>
                      </a:r>
                      <a:r>
                        <a:rPr lang="it-IT" sz="800" b="1" dirty="0"/>
                        <a:t> multiplex PCR Biomed2-derive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700" dirty="0"/>
                        <a:t>Volume= 50 µl </a:t>
                      </a:r>
                    </a:p>
                    <a:p>
                      <a:pPr algn="l"/>
                      <a:r>
                        <a:rPr lang="en-US" sz="700" dirty="0"/>
                        <a:t>diagnostic DNA =100 ng </a:t>
                      </a:r>
                    </a:p>
                    <a:p>
                      <a:pPr algn="l"/>
                      <a:r>
                        <a:rPr lang="en-US" sz="700" dirty="0"/>
                        <a:t>polyclonal DNA= 10 ng</a:t>
                      </a:r>
                    </a:p>
                    <a:p>
                      <a:pPr algn="l"/>
                      <a:endParaRPr lang="en-US" sz="700" dirty="0"/>
                    </a:p>
                    <a:p>
                      <a:pPr algn="l"/>
                      <a:r>
                        <a:rPr lang="en-US" sz="700" dirty="0"/>
                        <a:t>IG/TR clonal and polyclonal controls and no template controls (molecular grade water) were included with each run; each sample was tested in triplicate. </a:t>
                      </a:r>
                      <a:endParaRPr lang="it-IT" sz="700" dirty="0"/>
                    </a:p>
                    <a:p>
                      <a:pPr algn="l"/>
                      <a:endParaRPr lang="it-IT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700" dirty="0"/>
                        <a:t>After 1st PCR, gel electrophoresis was performed to check for successful amplification of all targets</a:t>
                      </a:r>
                    </a:p>
                    <a:p>
                      <a:pPr algn="just"/>
                      <a:endParaRPr lang="en-US" sz="700" dirty="0"/>
                    </a:p>
                    <a:p>
                      <a:pPr algn="just"/>
                      <a:r>
                        <a:rPr lang="en-US" sz="700" dirty="0"/>
                        <a:t>All 1st round PCR products, were diluted 1:50 unless amplicons were very weak; the PCR products with weak amplicons were used undiluted. </a:t>
                      </a:r>
                    </a:p>
                    <a:p>
                      <a:pPr algn="just"/>
                      <a:endParaRPr lang="it-IT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1" dirty="0"/>
                        <a:t>STEP 3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1" dirty="0"/>
                        <a:t>(</a:t>
                      </a:r>
                      <a:r>
                        <a:rPr lang="it-IT" sz="800" b="1" dirty="0" err="1"/>
                        <a:t>one-step</a:t>
                      </a:r>
                      <a:r>
                        <a:rPr lang="it-IT" sz="800" b="1" dirty="0"/>
                        <a:t> PCR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E</a:t>
                      </a:r>
                      <a:r>
                        <a:rPr lang="it-IT" sz="800" b="1" dirty="0">
                          <a:solidFill>
                            <a:schemeClr val="tx1"/>
                          </a:solidFill>
                        </a:rPr>
                        <a:t>x</a:t>
                      </a:r>
                      <a:r>
                        <a:rPr lang="it-IT" sz="800" b="1" dirty="0"/>
                        <a:t>tended multiplex PCR </a:t>
                      </a:r>
                      <a:r>
                        <a:rPr lang="it-IT" sz="800" b="1" dirty="0" err="1"/>
                        <a:t>LymphoTrack</a:t>
                      </a:r>
                      <a:r>
                        <a:rPr lang="it-IT" sz="800" b="1" dirty="0"/>
                        <a:t> primer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700" dirty="0"/>
                        <a:t>Volume= 50 µl </a:t>
                      </a:r>
                    </a:p>
                    <a:p>
                      <a:pPr algn="just"/>
                      <a:r>
                        <a:rPr lang="en-US" sz="700" dirty="0"/>
                        <a:t>diagnostic DNA =50 ng </a:t>
                      </a:r>
                    </a:p>
                    <a:p>
                      <a:pPr algn="just"/>
                      <a:r>
                        <a:rPr lang="en-US" sz="700" dirty="0"/>
                        <a:t>polyclonal DNA= 10 ng</a:t>
                      </a:r>
                    </a:p>
                    <a:p>
                      <a:pPr algn="just"/>
                      <a:endParaRPr lang="en-US" sz="700" dirty="0"/>
                    </a:p>
                    <a:p>
                      <a:pPr algn="just"/>
                      <a:r>
                        <a:rPr lang="en-US" sz="700" dirty="0"/>
                        <a:t>IG/TR clonal and polyclonal controls and no template controls (molecular grade water) were included with each run; each sample was tested in triplicate. </a:t>
                      </a:r>
                    </a:p>
                    <a:p>
                      <a:pPr algn="just"/>
                      <a:endParaRPr lang="it-IT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700" dirty="0"/>
                        <a:t>Direct incorporation of adapters.</a:t>
                      </a:r>
                    </a:p>
                    <a:p>
                      <a:pPr algn="just"/>
                      <a:endParaRPr lang="en-US" sz="700" dirty="0"/>
                    </a:p>
                    <a:p>
                      <a:pPr algn="just"/>
                      <a:r>
                        <a:rPr lang="en-US" sz="700" dirty="0"/>
                        <a:t>After PCR, amplicons were purified using the </a:t>
                      </a:r>
                      <a:r>
                        <a:rPr lang="en-US" sz="700" dirty="0" err="1"/>
                        <a:t>Agencourt</a:t>
                      </a:r>
                      <a:r>
                        <a:rPr lang="en-US" sz="700" dirty="0"/>
                        <a:t> </a:t>
                      </a:r>
                      <a:r>
                        <a:rPr lang="en-US" sz="700" dirty="0" err="1"/>
                        <a:t>AMPure</a:t>
                      </a:r>
                      <a:r>
                        <a:rPr lang="en-US" sz="700" dirty="0"/>
                        <a:t> XP system and quantified by using KAPA Library Quantification Kit according to the kit instructions: before proceeding with qPCR, the amplicons are diluted 1:4.000. </a:t>
                      </a:r>
                    </a:p>
                    <a:p>
                      <a:pPr algn="just"/>
                      <a:r>
                        <a:rPr lang="en-US" sz="700" dirty="0"/>
                        <a:t>After qPCR, the amplicons were pooled equimolarly into one final pool, diluted 1:1.000  and the library </a:t>
                      </a:r>
                      <a:r>
                        <a:rPr lang="en-US" sz="700" dirty="0" err="1"/>
                        <a:t>quantifed</a:t>
                      </a:r>
                      <a:r>
                        <a:rPr lang="en-US" sz="700" dirty="0"/>
                        <a:t> by using KAPA Library Quantification Kit.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876434"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4</a:t>
                      </a:r>
                    </a:p>
                    <a:p>
                      <a:pPr algn="ctr"/>
                      <a:r>
                        <a:rPr lang="it-IT" sz="800" b="1" dirty="0"/>
                        <a:t>(Second PCR)</a:t>
                      </a:r>
                    </a:p>
                    <a:p>
                      <a:pPr algn="ctr"/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 err="1"/>
                        <a:t>Adding</a:t>
                      </a:r>
                      <a:r>
                        <a:rPr lang="it-IT" sz="800" b="1" dirty="0"/>
                        <a:t> </a:t>
                      </a:r>
                      <a:r>
                        <a:rPr lang="en-US" sz="800" b="1" dirty="0"/>
                        <a:t>sequencing adaptors and sequencing indexes (barcodes)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700" dirty="0"/>
                        <a:t>Unique combination of forward and reverse indexes was used for each library.</a:t>
                      </a:r>
                    </a:p>
                    <a:p>
                      <a:endParaRPr lang="en-US" sz="700" dirty="0"/>
                    </a:p>
                    <a:p>
                      <a:r>
                        <a:rPr lang="en-US" sz="700" dirty="0"/>
                        <a:t> 1 µl of 1:50-diluted PCR products were amplified in the 2nd PCR.</a:t>
                      </a:r>
                    </a:p>
                    <a:p>
                      <a:endParaRPr lang="it-IT" sz="7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700" dirty="0"/>
                        <a:t>Following 2nd PCR, products from all samples of a run were pooled in </a:t>
                      </a:r>
                      <a:r>
                        <a:rPr lang="en-US" sz="700" dirty="0" err="1"/>
                        <a:t>equimolar</a:t>
                      </a:r>
                      <a:r>
                        <a:rPr lang="en-US" sz="700" dirty="0"/>
                        <a:t> ratios into </a:t>
                      </a:r>
                      <a:r>
                        <a:rPr lang="en-US" sz="700" dirty="0" err="1"/>
                        <a:t>subpools</a:t>
                      </a:r>
                      <a:r>
                        <a:rPr lang="en-US" sz="700" dirty="0"/>
                        <a:t> and purified by gel extraction. </a:t>
                      </a:r>
                    </a:p>
                    <a:p>
                      <a:endParaRPr lang="en-US" sz="700" dirty="0"/>
                    </a:p>
                    <a:p>
                      <a:r>
                        <a:rPr lang="en-US" sz="700" dirty="0"/>
                        <a:t>The </a:t>
                      </a:r>
                      <a:r>
                        <a:rPr lang="en-US" sz="700" dirty="0" err="1"/>
                        <a:t>subpools</a:t>
                      </a:r>
                      <a:r>
                        <a:rPr lang="en-US" sz="700" dirty="0"/>
                        <a:t> were pooled </a:t>
                      </a:r>
                      <a:r>
                        <a:rPr lang="en-US" sz="700" dirty="0" err="1"/>
                        <a:t>equimolarly</a:t>
                      </a:r>
                      <a:r>
                        <a:rPr lang="en-US" sz="700" dirty="0"/>
                        <a:t> into one final pool. </a:t>
                      </a:r>
                    </a:p>
                    <a:p>
                      <a:endParaRPr lang="it-IT" sz="7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 err="1"/>
                        <a:t>Sequencing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it-IT" sz="700" dirty="0"/>
                        <a:t>Illumina </a:t>
                      </a:r>
                      <a:r>
                        <a:rPr lang="it-IT" sz="700" dirty="0" err="1"/>
                        <a:t>MiSeq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plattform</a:t>
                      </a:r>
                      <a:endParaRPr lang="it-IT" sz="700" dirty="0"/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it-IT" sz="700" dirty="0" err="1"/>
                        <a:t>Ion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Torrent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plattform</a:t>
                      </a:r>
                      <a:endParaRPr lang="it-IT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700" dirty="0"/>
                        <a:t>Sequencing was performed using a final concentration of 12 </a:t>
                      </a:r>
                      <a:r>
                        <a:rPr lang="en-US" sz="700" dirty="0" err="1"/>
                        <a:t>pM</a:t>
                      </a:r>
                      <a:r>
                        <a:rPr lang="en-US" sz="700" dirty="0"/>
                        <a:t> for the </a:t>
                      </a:r>
                      <a:r>
                        <a:rPr lang="en-US" sz="700" dirty="0" err="1"/>
                        <a:t>amplicon</a:t>
                      </a:r>
                      <a:r>
                        <a:rPr lang="en-US" sz="700" dirty="0"/>
                        <a:t> library .</a:t>
                      </a:r>
                    </a:p>
                    <a:p>
                      <a:pPr algn="l"/>
                      <a:endParaRPr lang="en-US" sz="700" dirty="0"/>
                    </a:p>
                    <a:p>
                      <a:pPr algn="l"/>
                      <a:r>
                        <a:rPr lang="en-US" sz="700" dirty="0"/>
                        <a:t>The system is more tightly optimized for:</a:t>
                      </a:r>
                      <a:r>
                        <a:rPr lang="en-US" sz="700" baseline="0" dirty="0"/>
                        <a:t> </a:t>
                      </a:r>
                    </a:p>
                    <a:p>
                      <a:pPr algn="l"/>
                      <a:r>
                        <a:rPr lang="en-US" sz="700" dirty="0"/>
                        <a:t>• specific read lengths</a:t>
                      </a:r>
                    </a:p>
                    <a:p>
                      <a:pPr algn="l"/>
                      <a:r>
                        <a:rPr lang="en-US" sz="700" dirty="0"/>
                        <a:t>• specific run parameters</a:t>
                      </a:r>
                      <a:endParaRPr lang="it-IT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895381"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 err="1"/>
                        <a:t>Sequencing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it-IT" sz="700" dirty="0"/>
                        <a:t>Illumina </a:t>
                      </a:r>
                      <a:r>
                        <a:rPr lang="it-IT" sz="700" dirty="0" err="1"/>
                        <a:t>MiSeq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plattform</a:t>
                      </a:r>
                      <a:endParaRPr lang="it-IT" sz="700" dirty="0"/>
                    </a:p>
                    <a:p>
                      <a:pPr marL="171450" indent="-171450" algn="l">
                        <a:buFont typeface="Arial" panose="020B0604020202020204" pitchFamily="34" charset="0"/>
                        <a:buChar char="•"/>
                      </a:pPr>
                      <a:r>
                        <a:rPr lang="it-IT" sz="700" dirty="0" err="1"/>
                        <a:t>Ion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Torrent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plattform</a:t>
                      </a:r>
                      <a:endParaRPr lang="it-IT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700" dirty="0"/>
                        <a:t>Sequencing was performed using a final concentration of 7 </a:t>
                      </a:r>
                      <a:r>
                        <a:rPr lang="en-US" sz="700" dirty="0" err="1"/>
                        <a:t>pM</a:t>
                      </a:r>
                      <a:r>
                        <a:rPr lang="en-US" sz="700" dirty="0"/>
                        <a:t> for the </a:t>
                      </a:r>
                      <a:r>
                        <a:rPr lang="en-US" sz="700" dirty="0" err="1"/>
                        <a:t>amplicon</a:t>
                      </a:r>
                      <a:r>
                        <a:rPr lang="en-US" sz="700" dirty="0"/>
                        <a:t> library .</a:t>
                      </a:r>
                    </a:p>
                    <a:p>
                      <a:pPr algn="l"/>
                      <a:endParaRPr lang="en-US" sz="700" dirty="0"/>
                    </a:p>
                    <a:p>
                      <a:pPr algn="l"/>
                      <a:r>
                        <a:rPr lang="en-US" sz="700" dirty="0"/>
                        <a:t>Relatively deep readings:</a:t>
                      </a:r>
                    </a:p>
                    <a:p>
                      <a:pPr algn="l"/>
                      <a:r>
                        <a:rPr lang="en-US" sz="700" dirty="0"/>
                        <a:t>thousands-tens of </a:t>
                      </a:r>
                      <a:r>
                        <a:rPr lang="en-US" sz="700" dirty="0" smtClean="0"/>
                        <a:t>reads/sample</a:t>
                      </a:r>
                      <a:endParaRPr lang="it-IT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 err="1"/>
                        <a:t>Bioinformatic</a:t>
                      </a:r>
                      <a:r>
                        <a:rPr lang="it-IT" sz="800" b="1" dirty="0"/>
                        <a:t> </a:t>
                      </a:r>
                      <a:r>
                        <a:rPr lang="it-IT" sz="800" b="1" dirty="0" err="1"/>
                        <a:t>analysis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700" dirty="0"/>
                        <a:t>•</a:t>
                      </a:r>
                      <a:r>
                        <a:rPr lang="it-IT" sz="700" dirty="0" err="1"/>
                        <a:t>Lymphotrack</a:t>
                      </a:r>
                      <a:r>
                        <a:rPr lang="it-IT" sz="700" baseline="0" dirty="0"/>
                        <a:t> Software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 </a:t>
                      </a:r>
                    </a:p>
                    <a:p>
                      <a:pPr algn="l"/>
                      <a:r>
                        <a:rPr lang="it-IT" sz="700" dirty="0"/>
                        <a:t>•</a:t>
                      </a:r>
                      <a:r>
                        <a:rPr lang="it-IT" sz="700" baseline="0" dirty="0"/>
                        <a:t> </a:t>
                      </a:r>
                      <a:r>
                        <a:rPr lang="it-IT" sz="700" dirty="0"/>
                        <a:t>IMGT </a:t>
                      </a:r>
                      <a:r>
                        <a:rPr lang="it-IT" sz="700" dirty="0" err="1"/>
                        <a:t>integration</a:t>
                      </a:r>
                      <a:r>
                        <a:rPr lang="it-IT" sz="700" dirty="0"/>
                        <a:t>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700" dirty="0"/>
                        <a:t>• </a:t>
                      </a:r>
                      <a:r>
                        <a:rPr lang="it-IT" sz="700" dirty="0" err="1"/>
                        <a:t>Demultiplexing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</a:t>
                      </a:r>
                      <a:r>
                        <a:rPr lang="it-IT" sz="700" dirty="0" err="1"/>
                        <a:t>Quality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filtering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Error </a:t>
                      </a:r>
                      <a:r>
                        <a:rPr lang="it-IT" sz="700" dirty="0" err="1"/>
                        <a:t>correction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V/D/J </a:t>
                      </a:r>
                      <a:r>
                        <a:rPr lang="it-IT" sz="700" dirty="0" err="1"/>
                        <a:t>annotation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Junction/CDR3 </a:t>
                      </a:r>
                      <a:r>
                        <a:rPr lang="it-IT" sz="700" dirty="0" err="1"/>
                        <a:t>identification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% </a:t>
                      </a:r>
                      <a:r>
                        <a:rPr lang="it-IT" sz="700" dirty="0" err="1"/>
                        <a:t>Clonal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frequency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</a:t>
                      </a:r>
                      <a:r>
                        <a:rPr lang="it-IT" sz="700" dirty="0" err="1"/>
                        <a:t>Polyclonal</a:t>
                      </a:r>
                      <a:r>
                        <a:rPr lang="it-IT" sz="700" dirty="0"/>
                        <a:t> vs. </a:t>
                      </a:r>
                      <a:r>
                        <a:rPr lang="it-IT" sz="700" dirty="0" err="1"/>
                        <a:t>clonal</a:t>
                      </a:r>
                      <a:r>
                        <a:rPr lang="it-IT" sz="700" baseline="0" dirty="0"/>
                        <a:t> </a:t>
                      </a:r>
                      <a:r>
                        <a:rPr lang="it-IT" sz="700" dirty="0" err="1"/>
                        <a:t>interpretation</a:t>
                      </a:r>
                      <a:endParaRPr lang="it-IT" sz="7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924237"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 err="1"/>
                        <a:t>Bioinformatic</a:t>
                      </a:r>
                      <a:r>
                        <a:rPr lang="it-IT" sz="800" b="1" dirty="0"/>
                        <a:t> </a:t>
                      </a:r>
                      <a:r>
                        <a:rPr lang="it-IT" sz="800" b="1" dirty="0" err="1"/>
                        <a:t>analysis</a:t>
                      </a:r>
                      <a:endParaRPr lang="it-IT" sz="800" b="1" dirty="0"/>
                    </a:p>
                    <a:p>
                      <a:pPr algn="ctr"/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700" dirty="0"/>
                        <a:t>•</a:t>
                      </a:r>
                      <a:r>
                        <a:rPr lang="it-IT" sz="700" dirty="0" err="1"/>
                        <a:t>ARResT</a:t>
                      </a:r>
                      <a:r>
                        <a:rPr lang="it-IT" sz="700" dirty="0"/>
                        <a:t>/Interrogate</a:t>
                      </a:r>
                    </a:p>
                    <a:p>
                      <a:pPr algn="l"/>
                      <a:r>
                        <a:rPr lang="it-IT" sz="700" dirty="0"/>
                        <a:t> </a:t>
                      </a:r>
                    </a:p>
                    <a:p>
                      <a:pPr algn="l"/>
                      <a:r>
                        <a:rPr lang="it-IT" sz="700" dirty="0"/>
                        <a:t>•</a:t>
                      </a:r>
                      <a:r>
                        <a:rPr lang="it-IT" sz="700" baseline="0" dirty="0"/>
                        <a:t> </a:t>
                      </a:r>
                      <a:r>
                        <a:rPr lang="it-IT" sz="700" dirty="0"/>
                        <a:t>IMGT </a:t>
                      </a:r>
                      <a:r>
                        <a:rPr lang="it-IT" sz="700" dirty="0" err="1"/>
                        <a:t>integration</a:t>
                      </a:r>
                      <a:r>
                        <a:rPr lang="it-IT" sz="700" dirty="0"/>
                        <a:t>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700" dirty="0"/>
                        <a:t>• </a:t>
                      </a:r>
                      <a:r>
                        <a:rPr lang="it-IT" sz="700" dirty="0" err="1"/>
                        <a:t>Demultiplexing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</a:t>
                      </a:r>
                      <a:r>
                        <a:rPr lang="it-IT" sz="700" dirty="0" err="1"/>
                        <a:t>Quality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filtering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Error </a:t>
                      </a:r>
                      <a:r>
                        <a:rPr lang="it-IT" sz="700" dirty="0" err="1"/>
                        <a:t>correction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V/D/J </a:t>
                      </a:r>
                      <a:r>
                        <a:rPr lang="it-IT" sz="700" dirty="0" err="1"/>
                        <a:t>annotation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 Junction/CDR3 </a:t>
                      </a:r>
                      <a:r>
                        <a:rPr lang="it-IT" sz="700" dirty="0" err="1"/>
                        <a:t>identification</a:t>
                      </a:r>
                      <a:endParaRPr lang="it-IT" sz="700" dirty="0"/>
                    </a:p>
                    <a:p>
                      <a:pPr algn="l"/>
                      <a:r>
                        <a:rPr lang="it-IT" sz="700" dirty="0"/>
                        <a:t>•% </a:t>
                      </a:r>
                      <a:r>
                        <a:rPr lang="it-IT" sz="700" dirty="0" err="1"/>
                        <a:t>clonal</a:t>
                      </a:r>
                      <a:r>
                        <a:rPr lang="it-IT" sz="700" dirty="0"/>
                        <a:t> frequency</a:t>
                      </a:r>
                    </a:p>
                    <a:p>
                      <a:pPr algn="l"/>
                      <a:r>
                        <a:rPr lang="it-IT" sz="700" dirty="0"/>
                        <a:t>• </a:t>
                      </a:r>
                      <a:r>
                        <a:rPr lang="it-IT" sz="700" dirty="0" err="1"/>
                        <a:t>Polyclonal</a:t>
                      </a:r>
                      <a:r>
                        <a:rPr lang="it-IT" sz="700" dirty="0"/>
                        <a:t> vs. </a:t>
                      </a:r>
                      <a:r>
                        <a:rPr lang="it-IT" sz="700" dirty="0" err="1"/>
                        <a:t>clonal</a:t>
                      </a:r>
                      <a:r>
                        <a:rPr lang="it-IT" sz="700" dirty="0"/>
                        <a:t> </a:t>
                      </a:r>
                      <a:r>
                        <a:rPr lang="it-IT" sz="700" dirty="0" err="1"/>
                        <a:t>interpretation</a:t>
                      </a:r>
                      <a:endParaRPr lang="it-IT" sz="7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Target </a:t>
                      </a:r>
                      <a:r>
                        <a:rPr lang="it-IT" sz="800" b="1" dirty="0" err="1"/>
                        <a:t>definition</a:t>
                      </a:r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700" dirty="0"/>
                        <a:t>Longitudinally traceable dominant </a:t>
                      </a:r>
                      <a:r>
                        <a:rPr lang="en-US" sz="700" dirty="0" err="1"/>
                        <a:t>clonotype</a:t>
                      </a:r>
                      <a:r>
                        <a:rPr lang="en-US" sz="700" dirty="0"/>
                        <a:t> as a diagnostic marker</a:t>
                      </a:r>
                      <a:endParaRPr lang="it-IT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it-IT" sz="700" dirty="0">
                          <a:solidFill>
                            <a:schemeClr val="tx1"/>
                          </a:solidFill>
                        </a:rPr>
                        <a:t>•  CDR3 nucleotide </a:t>
                      </a:r>
                      <a:r>
                        <a:rPr lang="it-IT" sz="700" dirty="0" err="1">
                          <a:solidFill>
                            <a:schemeClr val="tx1"/>
                          </a:solidFill>
                        </a:rPr>
                        <a:t>sequence</a:t>
                      </a:r>
                      <a:endParaRPr lang="it-IT" sz="700" dirty="0">
                        <a:solidFill>
                          <a:schemeClr val="tx1"/>
                        </a:solidFill>
                      </a:endParaRPr>
                    </a:p>
                    <a:p>
                      <a:pPr algn="l"/>
                      <a:r>
                        <a:rPr lang="it-IT" sz="700" dirty="0">
                          <a:solidFill>
                            <a:schemeClr val="tx1"/>
                          </a:solidFill>
                        </a:rPr>
                        <a:t>• V-D-J </a:t>
                      </a:r>
                      <a:r>
                        <a:rPr lang="it-IT" sz="700" dirty="0" err="1">
                          <a:solidFill>
                            <a:schemeClr val="tx1"/>
                          </a:solidFill>
                        </a:rPr>
                        <a:t>combination</a:t>
                      </a:r>
                      <a:endParaRPr lang="it-IT" sz="700" dirty="0">
                        <a:solidFill>
                          <a:schemeClr val="tx1"/>
                        </a:solidFill>
                      </a:endParaRPr>
                    </a:p>
                    <a:p>
                      <a:pPr marL="0" lvl="0" algn="l" defTabSz="914400" rtl="0" eaLnBrk="1" latinLnBrk="0" hangingPunct="1"/>
                      <a:r>
                        <a:rPr lang="it-IT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• Dominant clone % </a:t>
                      </a:r>
                    </a:p>
                    <a:p>
                      <a:pPr algn="l"/>
                      <a:r>
                        <a:rPr lang="it-IT" sz="700" dirty="0"/>
                        <a:t>• </a:t>
                      </a:r>
                      <a:r>
                        <a:rPr lang="it-IT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Clone/background ratio </a:t>
                      </a:r>
                    </a:p>
                    <a:p>
                      <a:pPr algn="l"/>
                      <a:endParaRPr lang="it-IT" sz="7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945632"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STEP 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/>
                        <a:t>Target </a:t>
                      </a:r>
                      <a:r>
                        <a:rPr lang="it-IT" sz="800" b="1" dirty="0" err="1"/>
                        <a:t>definition</a:t>
                      </a:r>
                      <a:endParaRPr lang="it-IT" sz="800" b="1" dirty="0"/>
                    </a:p>
                    <a:p>
                      <a:pPr algn="ctr"/>
                      <a:endParaRPr lang="it-IT" sz="8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/>
                        <a:t>“Biologic family” of related sequences belonging to the same B/T clone</a:t>
                      </a:r>
                      <a:endParaRPr lang="it-IT" sz="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indent="0" algn="l" defTabSz="914400" rtl="0" eaLnBrk="1" latinLnBrk="0" hangingPunct="1">
                        <a:buFont typeface="Arial" panose="020B0604020202020204" pitchFamily="34" charset="0"/>
                        <a:buNone/>
                      </a:pPr>
                      <a:r>
                        <a:rPr lang="it-IT" sz="700" dirty="0"/>
                        <a:t>• 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Identification of the dominant rearrangement</a:t>
                      </a:r>
                    </a:p>
                    <a:p>
                      <a:pPr marL="0" indent="0" algn="l" defTabSz="914400" rtl="0" eaLnBrk="1" latinLnBrk="0" hangingPunct="1">
                        <a:buFont typeface="Arial" panose="020B0604020202020204" pitchFamily="34" charset="0"/>
                        <a:buNone/>
                      </a:pPr>
                      <a:r>
                        <a:rPr lang="it-IT" sz="700" dirty="0"/>
                        <a:t>• 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ssignment of:</a:t>
                      </a:r>
                    </a:p>
                    <a:p>
                      <a:pPr marL="0" indent="0" algn="l" defTabSz="914400" rtl="0" eaLnBrk="1" latinLnBrk="0" hangingPunct="1">
                        <a:buFont typeface="Arial" panose="020B0604020202020204" pitchFamily="34" charset="0"/>
                        <a:buNone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       -V, D, J gene</a:t>
                      </a:r>
                    </a:p>
                    <a:p>
                      <a:pPr marL="0" indent="0" algn="l" defTabSz="914400" rtl="0" eaLnBrk="1" latinLnBrk="0" hangingPunct="1">
                        <a:buFont typeface="Arial" panose="020B0604020202020204" pitchFamily="34" charset="0"/>
                        <a:buNone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       -CDR3 sequence</a:t>
                      </a:r>
                    </a:p>
                    <a:p>
                      <a:pPr marL="0" indent="0" algn="l" defTabSz="914400" rtl="0" eaLnBrk="1" latinLnBrk="0" hangingPunct="1">
                        <a:buFont typeface="Arial" panose="020B0604020202020204" pitchFamily="34" charset="0"/>
                        <a:buNone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       -Productivity</a:t>
                      </a:r>
                    </a:p>
                    <a:p>
                      <a:pPr marL="0" indent="0" algn="l" defTabSz="914400" rtl="0" eaLnBrk="1" latinLnBrk="0" hangingPunct="1">
                        <a:buFont typeface="Arial" panose="020B0604020202020204" pitchFamily="34" charset="0"/>
                        <a:buNone/>
                      </a:pPr>
                      <a:r>
                        <a:rPr lang="it-IT" sz="700" dirty="0"/>
                        <a:t>• </a:t>
                      </a: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Relative quantification of the clone in the repertoi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it-IT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15" name="CasellaDiTesto 14"/>
          <p:cNvSpPr txBox="1"/>
          <p:nvPr/>
        </p:nvSpPr>
        <p:spPr>
          <a:xfrm>
            <a:off x="16476" y="-41190"/>
            <a:ext cx="743535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400"/>
              <a:t>Table </a:t>
            </a:r>
            <a:r>
              <a:rPr lang="en-US" sz="1400" smtClean="0"/>
              <a:t>S 1. </a:t>
            </a:r>
            <a:r>
              <a:rPr lang="en-US" sz="1400" dirty="0"/>
              <a:t>Stepwise description of the </a:t>
            </a:r>
            <a:r>
              <a:rPr lang="en-US" sz="1400" dirty="0" err="1" smtClean="0"/>
              <a:t>EuroClonality</a:t>
            </a:r>
            <a:r>
              <a:rPr lang="en-US" sz="1400" dirty="0" smtClean="0"/>
              <a:t>-NGS </a:t>
            </a:r>
            <a:r>
              <a:rPr lang="en-US" sz="1400" dirty="0"/>
              <a:t>and </a:t>
            </a:r>
            <a:r>
              <a:rPr lang="en-US" sz="1400" dirty="0" err="1" smtClean="0"/>
              <a:t>LymphoTrack®methodologies</a:t>
            </a:r>
            <a:r>
              <a:rPr lang="en-US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5476049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55</Words>
  <Application>Microsoft Office PowerPoint</Application>
  <PresentationFormat>Widescreen</PresentationFormat>
  <Paragraphs>11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TEC</dc:creator>
  <cp:lastModifiedBy>TEC</cp:lastModifiedBy>
  <cp:revision>7</cp:revision>
  <dcterms:created xsi:type="dcterms:W3CDTF">2026-05-19T09:14:26Z</dcterms:created>
  <dcterms:modified xsi:type="dcterms:W3CDTF">2026-06-04T11:14:48Z</dcterms:modified>
</cp:coreProperties>
</file>